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5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4D7541-B9BB-138F-D3AD-C7D342AFBD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6BBE65-BB14-A9F1-BAF4-D193E767E1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2FA0E3-6420-BBB0-DA12-083332562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74DA34-0385-1E6E-12CA-B415791A1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867ED9-9BD5-02BD-ED59-4FF3D750A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324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677854-0150-90D7-8D5D-3192EF2C17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CB861B-8CB6-5CA9-558F-E898BF88F2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43FFDB-D6BB-ABE6-AEDF-1450B58C6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8F0F01-6E4E-2018-436D-F7A500DCC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E3F05F-9B5E-B31D-8EFF-5D34805B4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497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0E68F9-9A8C-F47B-5F17-608FBE70E1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283D68-6027-9158-1EEE-965D12CD1D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BA4A4D-9071-C41D-6DC3-E4A7B17C96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FEC669-350D-22FE-9E40-5D1AD9CFC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05FCF9-49AC-4D81-10D8-251E03A04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237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82754F-D8D8-7228-3049-A6C54C205D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AE665A-F0BE-D7E8-408B-852F875E3B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B4EA1-47F5-2C24-B7CB-2F5AF5C72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9B86FF-F098-DCE7-A695-61BD18F4C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7C987B-A9A8-9FD3-0C30-BBCE2776F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521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4E18B0-27C6-04C5-3F4E-664C0C0AAB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DFBC43-286F-3D6B-4C3E-5AE524EA59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011D44-C36E-EBF1-0F67-612E44C37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8719C6-A32E-2499-8E1A-B6639C18E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0CA990-AE98-8F66-1D61-FD3A1E459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498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A8994C-D89F-887A-B7B0-D9D9DADD2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642ED3-7A4B-6EBB-A64C-983139A4F1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293FC8-C485-82EC-DA43-A354933EFA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484993-5E8B-DE2E-B35F-278BDBB2F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7CB5B8-8BE5-15FB-4519-C211FAA84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A0247D-778A-90AB-4D84-0B8F3835E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186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537889-31D8-4559-E6AE-33142F1D14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7E1D15-C53B-812C-A0B8-F6163E4C3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F8CF0D-452E-EBA6-3502-FB45AE3678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13A20A-F759-08F4-0EF2-12D7E6D281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82F8423-85E0-CC13-41A4-E4673AFB97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BA4C606-2E74-F885-DA84-823FAF465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50B682-308D-9BAE-1BD4-3CF926297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784789-D25E-FCC8-D29B-E5E2CF460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654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61A120-85B7-804C-B18B-AD81FF422E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5D8BB06-E0AC-1858-5956-995301B71B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6BF49E-CC2A-05FF-E540-176A87D5D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3339CA4-6550-76B3-4731-1B7369214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368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020444-F3E4-A11D-5122-C6CB115D3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3F50478-8DDC-B5C8-B1FF-4D4B2462C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2D43A9B-4693-730A-0F7E-224E843D2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973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E87CBC-806F-6DC7-6822-FF459090A8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975C23-4B79-CB13-8071-22403F7C3D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E613DF-AD4B-5687-AC74-2241F0A744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E386F2-9906-DAB2-8FD8-5A332938CC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77CBAE-D6F4-A350-8C5E-426EAFD72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BA210C-1824-C989-E933-250819C33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397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1D0B1C-D2C5-9B28-5B75-2711011308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742BCBB-F351-7BBC-E712-2A15D35520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02F316-B8F1-26F1-6503-8A188EA222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E493A5-E641-4B13-1578-9A8CDC424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FB13EE-5981-F27B-1748-95A6C69A2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667122-0149-5DD7-8586-B7429CDD3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519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48AB95-387A-EE0A-76E5-1D3D1CE572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407848-0635-FA1F-6DD1-A6AC498D15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178A4D-163F-B01F-72C0-5555D55CC0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A999AA-32A5-4E0C-9776-FBDBAE33A900}" type="datetimeFigureOut">
              <a:rPr lang="en-US" smtClean="0"/>
              <a:t>5/3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FC744F-8ECD-B58F-B5BB-4406F39D8B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A3AB92-D7B7-B0B9-24E6-E34B067E6F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98BAD-B4E8-49D7-A16D-47E86237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947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A57FB9F8-A970-4F84-266A-70980D3A0C2D}"/>
              </a:ext>
            </a:extLst>
          </p:cNvPr>
          <p:cNvGrpSpPr/>
          <p:nvPr/>
        </p:nvGrpSpPr>
        <p:grpSpPr>
          <a:xfrm>
            <a:off x="2965320" y="1277910"/>
            <a:ext cx="5568315" cy="3690620"/>
            <a:chOff x="3311842" y="1583690"/>
            <a:chExt cx="5568315" cy="3690620"/>
          </a:xfrm>
        </p:grpSpPr>
        <p:pic>
          <p:nvPicPr>
            <p:cNvPr id="11" name="Picture 10" descr="A close-up of an x-ray&#10;&#10;Description automatically generated">
              <a:extLst>
                <a:ext uri="{FF2B5EF4-FFF2-40B4-BE49-F238E27FC236}">
                  <a16:creationId xmlns:a16="http://schemas.microsoft.com/office/drawing/2014/main" id="{01FFF211-9523-5102-2B01-03D01FEC38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08"/>
            <a:stretch/>
          </p:blipFill>
          <p:spPr>
            <a:xfrm>
              <a:off x="3311842" y="1583690"/>
              <a:ext cx="5568315" cy="3690620"/>
            </a:xfrm>
            <a:prstGeom prst="rect">
              <a:avLst/>
            </a:prstGeom>
          </p:spPr>
        </p:pic>
        <p:sp>
          <p:nvSpPr>
            <p:cNvPr id="12" name="Text Box 1">
              <a:extLst>
                <a:ext uri="{FF2B5EF4-FFF2-40B4-BE49-F238E27FC236}">
                  <a16:creationId xmlns:a16="http://schemas.microsoft.com/office/drawing/2014/main" id="{90FEC100-5816-6444-5799-DBDAC99AE739}"/>
                </a:ext>
              </a:extLst>
            </p:cNvPr>
            <p:cNvSpPr txBox="1"/>
            <p:nvPr/>
          </p:nvSpPr>
          <p:spPr>
            <a:xfrm>
              <a:off x="3365590" y="1642110"/>
              <a:ext cx="246380" cy="23431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A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" name="Text Box 1">
              <a:extLst>
                <a:ext uri="{FF2B5EF4-FFF2-40B4-BE49-F238E27FC236}">
                  <a16:creationId xmlns:a16="http://schemas.microsoft.com/office/drawing/2014/main" id="{45228D0E-6B3A-B22A-B14E-3CF7A3D6BE12}"/>
                </a:ext>
              </a:extLst>
            </p:cNvPr>
            <p:cNvSpPr txBox="1"/>
            <p:nvPr/>
          </p:nvSpPr>
          <p:spPr>
            <a:xfrm>
              <a:off x="6132920" y="1642110"/>
              <a:ext cx="246380" cy="23431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4" name="Text Box 1">
              <a:extLst>
                <a:ext uri="{FF2B5EF4-FFF2-40B4-BE49-F238E27FC236}">
                  <a16:creationId xmlns:a16="http://schemas.microsoft.com/office/drawing/2014/main" id="{E1D965F6-17AE-3D9C-32BF-5B8240466228}"/>
                </a:ext>
              </a:extLst>
            </p:cNvPr>
            <p:cNvSpPr txBox="1"/>
            <p:nvPr/>
          </p:nvSpPr>
          <p:spPr>
            <a:xfrm>
              <a:off x="3377655" y="3510915"/>
              <a:ext cx="246380" cy="23431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" name="Text Box 1">
              <a:extLst>
                <a:ext uri="{FF2B5EF4-FFF2-40B4-BE49-F238E27FC236}">
                  <a16:creationId xmlns:a16="http://schemas.microsoft.com/office/drawing/2014/main" id="{D8C3F724-9D3E-9601-F08C-FB1AA930DC07}"/>
                </a:ext>
              </a:extLst>
            </p:cNvPr>
            <p:cNvSpPr txBox="1"/>
            <p:nvPr/>
          </p:nvSpPr>
          <p:spPr>
            <a:xfrm>
              <a:off x="6132920" y="3518535"/>
              <a:ext cx="246380" cy="23431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D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8A2D8BC4-70E7-36A9-B149-75B996AFBF11}"/>
              </a:ext>
            </a:extLst>
          </p:cNvPr>
          <p:cNvSpPr txBox="1"/>
          <p:nvPr/>
        </p:nvSpPr>
        <p:spPr>
          <a:xfrm>
            <a:off x="1581652" y="5227439"/>
            <a:ext cx="902869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: </a:t>
            </a:r>
            <a:r>
              <a:rPr lang="en-US" sz="18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ARRP </a:t>
            </a:r>
            <a:r>
              <a:rPr lang="en-US" sz="180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uriplan</a:t>
            </a:r>
            <a:r>
              <a:rPr lang="en-US" sz="18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reatment plan for the focal RIPF model illustrating the 3 x 3 mm collimator centered in the left lung (isoC_1) using CT imaging guidance.</a:t>
            </a:r>
            <a:r>
              <a:rPr lang="en-US" sz="1800" b="1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 </a:t>
            </a:r>
            <a:r>
              <a:rPr lang="en-US" sz="18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xial cross-section (a), sagittal cross-section (b), and coronal cross-section (d), respectively.  3-D rendering of the mouse with the AP:PA beams (c)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40874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9994B03B-1602-DA3E-242F-2F7ED2450192}"/>
              </a:ext>
            </a:extLst>
          </p:cNvPr>
          <p:cNvGrpSpPr/>
          <p:nvPr/>
        </p:nvGrpSpPr>
        <p:grpSpPr>
          <a:xfrm>
            <a:off x="3138805" y="1467485"/>
            <a:ext cx="5914390" cy="3923030"/>
            <a:chOff x="3138805" y="1467485"/>
            <a:chExt cx="5914390" cy="392303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2F9B007-51CA-E4F2-8FEF-FB9F2DB39A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36"/>
            <a:stretch/>
          </p:blipFill>
          <p:spPr bwMode="auto">
            <a:xfrm>
              <a:off x="3138805" y="1467485"/>
              <a:ext cx="5914390" cy="392303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7" name="Text Box 1">
              <a:extLst>
                <a:ext uri="{FF2B5EF4-FFF2-40B4-BE49-F238E27FC236}">
                  <a16:creationId xmlns:a16="http://schemas.microsoft.com/office/drawing/2014/main" id="{3F1DDDDC-272E-27FD-F6CF-8F7C21D60B9F}"/>
                </a:ext>
              </a:extLst>
            </p:cNvPr>
            <p:cNvSpPr txBox="1"/>
            <p:nvPr/>
          </p:nvSpPr>
          <p:spPr>
            <a:xfrm>
              <a:off x="3202113" y="1520827"/>
              <a:ext cx="246380" cy="23431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" name="Text Box 1">
              <a:extLst>
                <a:ext uri="{FF2B5EF4-FFF2-40B4-BE49-F238E27FC236}">
                  <a16:creationId xmlns:a16="http://schemas.microsoft.com/office/drawing/2014/main" id="{526EA3EF-F0AE-96DE-8721-8C7CA8C6C639}"/>
                </a:ext>
              </a:extLst>
            </p:cNvPr>
            <p:cNvSpPr txBox="1"/>
            <p:nvPr/>
          </p:nvSpPr>
          <p:spPr>
            <a:xfrm>
              <a:off x="6154269" y="1520827"/>
              <a:ext cx="246380" cy="23431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9" name="Text Box 1">
              <a:extLst>
                <a:ext uri="{FF2B5EF4-FFF2-40B4-BE49-F238E27FC236}">
                  <a16:creationId xmlns:a16="http://schemas.microsoft.com/office/drawing/2014/main" id="{3126B489-7F17-2078-B75B-1894C0D15C80}"/>
                </a:ext>
              </a:extLst>
            </p:cNvPr>
            <p:cNvSpPr txBox="1"/>
            <p:nvPr/>
          </p:nvSpPr>
          <p:spPr>
            <a:xfrm>
              <a:off x="3214178" y="3525824"/>
              <a:ext cx="246380" cy="23431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0" name="Text Box 1">
              <a:extLst>
                <a:ext uri="{FF2B5EF4-FFF2-40B4-BE49-F238E27FC236}">
                  <a16:creationId xmlns:a16="http://schemas.microsoft.com/office/drawing/2014/main" id="{4383AE76-2544-DE03-8B6C-5D26B1C019F9}"/>
                </a:ext>
              </a:extLst>
            </p:cNvPr>
            <p:cNvSpPr txBox="1"/>
            <p:nvPr/>
          </p:nvSpPr>
          <p:spPr>
            <a:xfrm>
              <a:off x="6154269" y="3533444"/>
              <a:ext cx="246380" cy="23431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D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26FEB636-AA37-6743-FCFD-E6980D3623AA}"/>
              </a:ext>
            </a:extLst>
          </p:cNvPr>
          <p:cNvSpPr txBox="1"/>
          <p:nvPr/>
        </p:nvSpPr>
        <p:spPr>
          <a:xfrm>
            <a:off x="1439128" y="5442786"/>
            <a:ext cx="965067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2: </a:t>
            </a:r>
            <a:r>
              <a:rPr lang="en-US" sz="18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ARRP </a:t>
            </a:r>
            <a:r>
              <a:rPr lang="en-US" sz="180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uriplan</a:t>
            </a:r>
            <a:r>
              <a:rPr lang="en-US" sz="18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treatment plan for the whole lung RIPF model illustrating the 10 x 10 mm collimator centered in the right lung (isoC_1) using CT imaging guidance.</a:t>
            </a:r>
            <a:r>
              <a:rPr lang="en-US" sz="1800" b="1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 </a:t>
            </a:r>
            <a:r>
              <a:rPr lang="en-US" sz="18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xial cross-section (a), sagittal cross-section (b), and coronal cross-section (d), respectively.  3-D rendering of the mouse with the AP:PA beams (c)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35412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5">
            <a:extLst>
              <a:ext uri="{FF2B5EF4-FFF2-40B4-BE49-F238E27FC236}">
                <a16:creationId xmlns:a16="http://schemas.microsoft.com/office/drawing/2014/main" id="{AD65C92B-D57F-7614-A667-8DD2147AF5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6324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0C03665-BB27-F4D8-C238-A9713CA650B5}"/>
              </a:ext>
            </a:extLst>
          </p:cNvPr>
          <p:cNvGrpSpPr/>
          <p:nvPr/>
        </p:nvGrpSpPr>
        <p:grpSpPr>
          <a:xfrm>
            <a:off x="3080194" y="224432"/>
            <a:ext cx="5791200" cy="5175250"/>
            <a:chOff x="3112851" y="126460"/>
            <a:chExt cx="5791200" cy="5175250"/>
          </a:xfrm>
        </p:grpSpPr>
        <p:pic>
          <p:nvPicPr>
            <p:cNvPr id="1026" name="Picture 313562170" descr="A close-up of a x-ray&#10;&#10;Description automatically generated">
              <a:extLst>
                <a:ext uri="{FF2B5EF4-FFF2-40B4-BE49-F238E27FC236}">
                  <a16:creationId xmlns:a16="http://schemas.microsoft.com/office/drawing/2014/main" id="{CE28261B-89B5-FFA1-0775-9F6C6E0FA8B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12851" y="126460"/>
              <a:ext cx="5791200" cy="25685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5" name="Picture 248953383" descr="A close-up of a ct scan&#10;&#10;Description automatically generated">
              <a:extLst>
                <a:ext uri="{FF2B5EF4-FFF2-40B4-BE49-F238E27FC236}">
                  <a16:creationId xmlns:a16="http://schemas.microsoft.com/office/drawing/2014/main" id="{F95878FE-4EF9-2B7A-252A-B65C4F45C86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12851" y="2695035"/>
              <a:ext cx="5791200" cy="26066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 Box 1">
              <a:extLst>
                <a:ext uri="{FF2B5EF4-FFF2-40B4-BE49-F238E27FC236}">
                  <a16:creationId xmlns:a16="http://schemas.microsoft.com/office/drawing/2014/main" id="{B34F4B08-CBDA-86A5-5007-C512F2C33530}"/>
                </a:ext>
              </a:extLst>
            </p:cNvPr>
            <p:cNvSpPr txBox="1"/>
            <p:nvPr/>
          </p:nvSpPr>
          <p:spPr>
            <a:xfrm>
              <a:off x="3202113" y="197866"/>
              <a:ext cx="246380" cy="23431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6" name="Text Box 1">
              <a:extLst>
                <a:ext uri="{FF2B5EF4-FFF2-40B4-BE49-F238E27FC236}">
                  <a16:creationId xmlns:a16="http://schemas.microsoft.com/office/drawing/2014/main" id="{91E07828-B5FF-84E7-074E-16C96B99DE5B}"/>
                </a:ext>
              </a:extLst>
            </p:cNvPr>
            <p:cNvSpPr txBox="1"/>
            <p:nvPr/>
          </p:nvSpPr>
          <p:spPr>
            <a:xfrm>
              <a:off x="3182660" y="2766441"/>
              <a:ext cx="246380" cy="234315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E679AE1D-5FD2-1480-4E39-6472E2836872}"/>
              </a:ext>
            </a:extLst>
          </p:cNvPr>
          <p:cNvSpPr txBox="1"/>
          <p:nvPr/>
        </p:nvSpPr>
        <p:spPr>
          <a:xfrm>
            <a:off x="722278" y="5528857"/>
            <a:ext cx="1114546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l Figure 3.</a:t>
            </a:r>
            <a:r>
              <a:rPr lang="en-US" sz="18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In the focal RIPF model, a representative small animal [</a:t>
            </a:r>
            <a:r>
              <a:rPr lang="en-US" sz="1800" baseline="300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64</a:t>
            </a:r>
            <a:r>
              <a:rPr lang="en-US" sz="18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u]Cu-</a:t>
            </a:r>
            <a:r>
              <a:rPr lang="en-US" sz="18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α</a:t>
            </a:r>
            <a:r>
              <a:rPr lang="en-US" sz="1800" baseline="-25000" dirty="0" err="1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ν</a:t>
            </a:r>
            <a:r>
              <a:rPr lang="en-US" sz="18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800" baseline="-250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6</a:t>
            </a:r>
            <a:r>
              <a:rPr lang="en-US" sz="18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BP PET/CT fusion image 8 weeks post-RT. The top panel shows an area of increased density in the treated region (3 x 3 mm collimator) with CT imaging and the bottom panel illustrates a corresponding region of increased [</a:t>
            </a:r>
            <a:r>
              <a:rPr lang="en-US" sz="1800" baseline="300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64</a:t>
            </a:r>
            <a:r>
              <a:rPr lang="en-US" sz="18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u]Cu-</a:t>
            </a:r>
            <a:r>
              <a:rPr lang="en-US" sz="18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α</a:t>
            </a:r>
            <a:r>
              <a:rPr lang="en-US" sz="1800" baseline="-250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ν</a:t>
            </a:r>
            <a:r>
              <a:rPr lang="en-US" sz="18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β</a:t>
            </a:r>
            <a:r>
              <a:rPr lang="en-US" sz="1800" baseline="-250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6</a:t>
            </a:r>
            <a:r>
              <a:rPr lang="en-US" sz="18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BP uptake with PET imaging. 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7714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14</Words>
  <Application>Microsoft Macintosh PowerPoint</Application>
  <PresentationFormat>Widescreen</PresentationFormat>
  <Paragraphs>1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</dc:creator>
  <cp:lastModifiedBy>Carmen Bergom</cp:lastModifiedBy>
  <cp:revision>7</cp:revision>
  <dcterms:created xsi:type="dcterms:W3CDTF">2024-03-16T19:06:41Z</dcterms:created>
  <dcterms:modified xsi:type="dcterms:W3CDTF">2024-05-30T16:59:55Z</dcterms:modified>
</cp:coreProperties>
</file>